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12B260A-8095-4985-82D0-6D2ABCAC5F52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D0F5E77-E152-42DA-AC18-B1D9D3FD9C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A8EF4E6-9341-47B3-BFEF-92952DCDB9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2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54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30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2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54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986137C-28E9-4DC3-9438-8F572697FE17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34E277D-A768-445A-B55F-A3F7DE2818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AE97B9A-3863-42E6-B8DC-4E7BD1BA3F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0957BAE-D693-42E3-9018-7781B1DFD5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0447276-2EAE-4836-8715-099E9833D28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3080" y="366480"/>
            <a:ext cx="6170400" cy="705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B21E841-CE0B-4029-9864-F7332D97DCE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6E90B7D-709B-464D-9E04-946473BDB3C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4EA33CC-FBF7-4EDC-9FB0-1C2A64FDFDD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760B8E8-A056-40E5-8D02-21A3CDA7B3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3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2/23/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"/>
          <p:cNvSpPr/>
          <p:nvPr/>
        </p:nvSpPr>
        <p:spPr>
          <a:xfrm>
            <a:off x="2343240" y="8475840"/>
            <a:ext cx="2171520" cy="48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sldNum" idx="2"/>
          </p:nvPr>
        </p:nvSpPr>
        <p:spPr>
          <a:xfrm>
            <a:off x="4915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135496FF-B9BD-4CE0-B775-F0B30F70F9F6}" type="slidenum">
              <a:rPr b="0" lang="en-US" sz="18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982800" y="376200"/>
          <a:ext cx="4889520" cy="4267080"/>
        </p:xfrm>
        <a:graphic>
          <a:graphicData uri="http://schemas.openxmlformats.org/drawingml/2006/table">
            <a:tbl>
              <a:tblPr/>
              <a:tblGrid>
                <a:gridCol w="2705400"/>
                <a:gridCol w="1091880"/>
                <a:gridCol w="1092240"/>
              </a:tblGrid>
              <a:tr h="355320"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opamine antagonist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utan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le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355320"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moxapin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2410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1475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</a:tr>
              <a:tr h="354960"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lomipramine hydrochlorid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2194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4899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55680"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lozapin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4718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2650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</a:tr>
              <a:tr h="355320"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omperidone malea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8690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2438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55320"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roperido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2520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077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</a:tr>
              <a:tr h="355320"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toclopramide monohydrochlorid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2419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1416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55320"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isperidon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2937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0234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</a:tr>
              <a:tr h="355320"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hiethylperazine mala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0576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845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55320"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hioridazine hydrochlorid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4707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1503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</a:tr>
              <a:tr h="355320"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rifluoperazine dihydrochlorid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53721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202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58560"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rimipramine maleate sal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2051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" rIns="9000" tIns="1944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0018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" marR="90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42" name=""/>
          <p:cNvGraphicFramePr/>
          <p:nvPr/>
        </p:nvGraphicFramePr>
        <p:xfrm>
          <a:off x="982800" y="4800600"/>
          <a:ext cx="4876560" cy="3206880"/>
        </p:xfrm>
        <a:graphic>
          <a:graphicData uri="http://schemas.openxmlformats.org/drawingml/2006/table">
            <a:tbl>
              <a:tblPr/>
              <a:tblGrid>
                <a:gridCol w="2286000"/>
                <a:gridCol w="1295280"/>
                <a:gridCol w="1295280"/>
              </a:tblGrid>
              <a:tr h="356400">
                <a:tc>
                  <a:txBody>
                    <a:bodyPr lIns="9360" rIns="9360" tIns="1980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midazole antifungal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9360" rIns="9360" tIns="1980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utan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9360" rIns="9360" tIns="1980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le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356400">
                <a:tc>
                  <a:txBody>
                    <a:bodyPr lIns="9360" rIns="9360" tIns="1980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utoconazole nitra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1980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53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1980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7445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</a:tr>
              <a:tr h="356760">
                <a:tc>
                  <a:txBody>
                    <a:bodyPr lIns="9360" rIns="9360" tIns="1980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lotrimazol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360" rIns="9360" tIns="1980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2753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360" rIns="9360" tIns="1980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1084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56400">
                <a:tc>
                  <a:txBody>
                    <a:bodyPr lIns="9360" rIns="9360" tIns="1980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conazole nitra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1980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4154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1980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5505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</a:tr>
              <a:tr h="356400">
                <a:tc>
                  <a:txBody>
                    <a:bodyPr lIns="9360" rIns="9360" tIns="1980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soconazol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360" rIns="9360" tIns="1980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0849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360" rIns="9360" tIns="1980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1087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56400">
                <a:tc>
                  <a:txBody>
                    <a:bodyPr lIns="9360" rIns="9360" tIns="1980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etoconazol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1980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0885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1980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0328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</a:tr>
              <a:tr h="356400">
                <a:tc>
                  <a:txBody>
                    <a:bodyPr lIns="9360" rIns="9360" tIns="1980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iconazol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360" rIns="9360" tIns="1980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0596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360" rIns="9360" tIns="1980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.9642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56760">
                <a:tc>
                  <a:txBody>
                    <a:bodyPr lIns="9360" rIns="9360" tIns="1980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rtaconazole nitra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1980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9485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360" rIns="9360" tIns="1980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4082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</a:tr>
              <a:tr h="354960">
                <a:tc>
                  <a:txBody>
                    <a:bodyPr lIns="9360" rIns="9360" tIns="1980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ulconazole nitra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360" rIns="9360" tIns="1980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7604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360" rIns="9360" tIns="19800" bIns="0" anchor="ctr">
                      <a:noAutofit/>
                    </a:bodyPr>
                    <a:p>
                      <a:pPr algn="ctr">
                        <a:lnSpc>
                          <a:spcPct val="93000"/>
                        </a:lnSpc>
                        <a:tabLst>
                          <a:tab algn="l" pos="0"/>
                          <a:tab algn="l" pos="723960"/>
                          <a:tab algn="l" pos="1447920"/>
                          <a:tab algn="l" pos="2171880"/>
                          <a:tab algn="l" pos="2895480"/>
                          <a:tab algn="l" pos="3619440"/>
                          <a:tab algn="l" pos="43434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  <a:tab algn="l" pos="9601200"/>
                          <a:tab algn="l" pos="10058400"/>
                          <a:tab algn="l" pos="105156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70203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43" name="PlaceHolder 1"/>
          <p:cNvSpPr>
            <a:spLocks noGrp="1"/>
          </p:cNvSpPr>
          <p:nvPr>
            <p:ph type="title"/>
          </p:nvPr>
        </p:nvSpPr>
        <p:spPr>
          <a:xfrm>
            <a:off x="5409720" y="8153280"/>
            <a:ext cx="1219320" cy="1663920"/>
          </a:xfrm>
          <a:prstGeom prst="rect">
            <a:avLst/>
          </a:prstGeom>
          <a:noFill/>
          <a:ln w="0">
            <a:noFill/>
          </a:ln>
        </p:spPr>
        <p:txBody>
          <a:bodyPr tIns="91440" anchor="t">
            <a:noAutofit/>
          </a:bodyPr>
          <a:p>
            <a:pPr indent="0" algn="r">
              <a:lnSpc>
                <a:spcPct val="100000"/>
              </a:lnSpc>
              <a:buNone/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dditional file 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